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9900"/>
    <a:srgbClr val="FF66CC"/>
    <a:srgbClr val="00CCFF"/>
    <a:srgbClr val="33CCCC"/>
    <a:srgbClr val="FF99FF"/>
    <a:srgbClr val="669E40"/>
    <a:srgbClr val="11C1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>
        <p:scale>
          <a:sx n="125" d="100"/>
          <a:sy n="125" d="100"/>
        </p:scale>
        <p:origin x="858" y="-3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6747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096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6241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116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798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021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126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729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217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6909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13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12E785-EBA5-4184-9B0A-04A58D426854}" type="datetimeFigureOut">
              <a:rPr lang="en-US" smtClean="0"/>
              <a:t>7/1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1AD27-40D5-442C-B6A0-9F7C3A345B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020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65F25A9E-77B0-28E3-99CF-C2C86F654C98}"/>
              </a:ext>
            </a:extLst>
          </p:cNvPr>
          <p:cNvGrpSpPr/>
          <p:nvPr/>
        </p:nvGrpSpPr>
        <p:grpSpPr>
          <a:xfrm>
            <a:off x="873864" y="1430144"/>
            <a:ext cx="4791476" cy="5131723"/>
            <a:chOff x="424659" y="553720"/>
            <a:chExt cx="4791476" cy="5131723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21B348D2-652C-40E3-BF45-D846B92C058A}"/>
                </a:ext>
              </a:extLst>
            </p:cNvPr>
            <p:cNvPicPr/>
            <p:nvPr/>
          </p:nvPicPr>
          <p:blipFill rotWithShape="1">
            <a:blip r:embed="rId2"/>
            <a:srcRect l="2108" t="6012" r="1371" b="9527"/>
            <a:stretch/>
          </p:blipFill>
          <p:spPr>
            <a:xfrm>
              <a:off x="539015" y="695326"/>
              <a:ext cx="4677120" cy="929318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27868150-55C9-49A5-BDCA-73BE30D4C15D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014" y="1600200"/>
              <a:ext cx="4585435" cy="103964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id="{F455B8D9-8239-43AC-9EC1-0A34EC88A35F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015" y="2615400"/>
              <a:ext cx="4585434" cy="103964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1354400A-B40A-4DCB-8F5C-1174CC4D0AF6}"/>
                </a:ext>
              </a:extLst>
            </p:cNvPr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014" y="3627597"/>
              <a:ext cx="4677119" cy="104264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93F1772D-8E9A-4CE0-B334-F4D0D0222361}"/>
                </a:ext>
              </a:extLst>
            </p:cNvPr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9015" y="4649787"/>
              <a:ext cx="4645760" cy="1035656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4DC860B5-57D0-41DC-88A9-FBBDE6FD2024}"/>
                </a:ext>
              </a:extLst>
            </p:cNvPr>
            <p:cNvSpPr txBox="1"/>
            <p:nvPr/>
          </p:nvSpPr>
          <p:spPr>
            <a:xfrm>
              <a:off x="424659" y="553720"/>
              <a:ext cx="281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1BFD1250-1DD4-4345-A77B-405A3EEADBCA}"/>
                </a:ext>
              </a:extLst>
            </p:cNvPr>
            <p:cNvSpPr txBox="1"/>
            <p:nvPr/>
          </p:nvSpPr>
          <p:spPr>
            <a:xfrm>
              <a:off x="424659" y="4547939"/>
              <a:ext cx="281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BC1A8897-A31D-46D7-B7A1-E2A93DCABC07}"/>
                </a:ext>
              </a:extLst>
            </p:cNvPr>
            <p:cNvSpPr txBox="1"/>
            <p:nvPr/>
          </p:nvSpPr>
          <p:spPr>
            <a:xfrm>
              <a:off x="424659" y="3591648"/>
              <a:ext cx="281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D7556C2B-8CC4-45C6-8DB7-7646E9732B80}"/>
                </a:ext>
              </a:extLst>
            </p:cNvPr>
            <p:cNvSpPr txBox="1"/>
            <p:nvPr/>
          </p:nvSpPr>
          <p:spPr>
            <a:xfrm>
              <a:off x="424659" y="2465302"/>
              <a:ext cx="281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5FA457E-7533-4B61-91F5-01984C8572A8}"/>
                </a:ext>
              </a:extLst>
            </p:cNvPr>
            <p:cNvSpPr txBox="1"/>
            <p:nvPr/>
          </p:nvSpPr>
          <p:spPr>
            <a:xfrm>
              <a:off x="424659" y="1500104"/>
              <a:ext cx="2811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Box 6">
            <a:extLst>
              <a:ext uri="{FF2B5EF4-FFF2-40B4-BE49-F238E27FC236}">
                <a16:creationId xmlns:a16="http://schemas.microsoft.com/office/drawing/2014/main" id="{E20FF6AF-7990-42F2-BDE8-5E84F5E9022B}"/>
              </a:ext>
            </a:extLst>
          </p:cNvPr>
          <p:cNvSpPr txBox="1"/>
          <p:nvPr/>
        </p:nvSpPr>
        <p:spPr>
          <a:xfrm>
            <a:off x="429347" y="6723552"/>
            <a:ext cx="570317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plots of –Log10(p) vs. chromosomal position of SNP markers associated with ginsenoside Rg1 content and quantile-quantile (QQ) plots in a Jilin ginseng core collection using five multiple locus models, (A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rML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TmrML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TmrEMM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D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KWmE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E) ISIS EM-BLASSO. A blue dash line represents the significant –Log10(p) = 2.54 X 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7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Bonferroni correction method.</a:t>
            </a:r>
          </a:p>
        </p:txBody>
      </p:sp>
    </p:spTree>
    <p:extLst>
      <p:ext uri="{BB962C8B-B14F-4D97-AF65-F5344CB8AC3E}">
        <p14:creationId xmlns:p14="http://schemas.microsoft.com/office/powerpoint/2010/main" val="2534644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9</TotalTime>
  <Words>92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exas A and M AgriLif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Meiping</dc:creator>
  <cp:lastModifiedBy>MDPI</cp:lastModifiedBy>
  <cp:revision>85</cp:revision>
  <dcterms:created xsi:type="dcterms:W3CDTF">2022-03-07T00:48:16Z</dcterms:created>
  <dcterms:modified xsi:type="dcterms:W3CDTF">2024-07-10T09:22:41Z</dcterms:modified>
</cp:coreProperties>
</file>